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2" r:id="rId2"/>
    <p:sldId id="456" r:id="rId3"/>
    <p:sldId id="4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42133" autoAdjust="0"/>
  </p:normalViewPr>
  <p:slideViewPr>
    <p:cSldViewPr snapToGrid="0">
      <p:cViewPr varScale="1">
        <p:scale>
          <a:sx n="25" d="100"/>
          <a:sy n="25" d="100"/>
        </p:scale>
        <p:origin x="217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0BDEF4-5A75-478E-8D41-CD76DD994D07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253254-99DA-4257-9F05-8724708EB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20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253254-99DA-4257-9F05-8724708EBD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6806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253254-99DA-4257-9F05-8724708EBD1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6964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253254-99DA-4257-9F05-8724708EBD1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9547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20660C-ED66-4294-A277-8240DCA50E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FB5603F-C24F-446B-90DA-A7C86A0E9E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49399-615E-44FC-B12C-185AFC251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3162C4-A92E-4AFC-9EEE-C05EE934F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AC550C-CA12-479B-A16C-0CDC07D79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125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CB19C-A997-4E31-B143-37350EDB33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C38818-5122-4BAC-B8B1-83060400B3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C1DF13-511C-4901-BAD2-3079BB084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AB7C5-A95E-403A-990F-46302017C9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9FBFF0-98F9-4B2F-BD40-900717C3A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075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816EE3-3ED2-4DC1-9C2D-A6F5717358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CAB433-8AF6-4A5B-B6DF-03C9BE0E4D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7FC48-279E-48B9-8E31-534E83D19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0192E-FF9A-466A-A83E-553DC7D30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74A33F-6242-4C20-B250-11814BF99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499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6470A-E59C-4DD8-BFE4-3A0D30783F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7A6DF0-2D65-4EB8-A955-1B13D03D48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0AB257-10BD-47AF-86CA-C16BA3E2E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A30BBA-7D0E-4247-A8DC-BFBFD66E8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D49DC1-80E3-4743-90C4-4CA11202D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367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820A0-1197-4AC6-8A97-41D9CF3FC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28D297-CE44-4CD3-BF31-55C1FB805A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6508F-9A15-43F6-BB65-079A17D56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03DB4C-C75C-4E10-AD3C-20424107C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2CB44D-2F50-4FA7-9B35-5F67BAF9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10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31E05-0B62-45E8-9493-AAED1760C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5C760A-80E0-4588-999E-6DDE5AC198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184D0F-0D2B-4C05-9554-5E415925D3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DF3065-7E0A-415F-AB20-4707EB5DE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DB6ED7-7552-4F89-AD96-392274698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328CCB-37E4-4227-99BA-76A403ED4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909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9054FA-7F3D-4C36-8591-038DA6791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74A852-013C-491A-9721-96D86F7912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AC068-EFBA-46D8-A645-4BD0EE80E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BAEE8D-84E9-4D47-9079-32780245C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E5AE95-B4C0-42FC-B090-E7EA4EC5FF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F9C2BEA-CD91-4D57-A473-C43BC16BB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873D60-DC60-4498-BE32-7EB5B0AFC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E88E05-2060-4FFA-8483-4269078B7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681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0C5C5B-02BC-49B6-9B53-12B447BF4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D70BBF-DED9-40F0-93D8-A2AF70BF9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55C302-C142-408D-A763-AE0216C69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79AFEC-9038-49C6-8750-E327EF321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710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717AC3-D83A-4996-B9E6-BF35DDED8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F87CF8-BAC8-41C0-89A9-7D416BAAC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F7BAE5-D99F-4279-8B36-70CF6DABD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728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1FA4C-5027-4755-ABB5-05DE49F54E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45A755-647A-4577-9819-78352AE321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424415-B9E3-4D22-905D-899E9DBF02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3E2A80-0CFA-482E-A7BD-26745AADE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905524-D9A0-440F-BD06-CF2DBE44F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E38CA5-43A5-485E-BAB2-DF03A9F3A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917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62214-9023-4777-8E23-F59211D785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0D644B-27C7-486C-9A56-8518C9FD47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BA6F61-0A6A-4E8E-BCB8-6D0E9437CB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2E2BB0-C202-4867-BB7A-0BA51C11E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7CF52-CB82-45C1-AB5E-2C58F0F0A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1E3983-7665-4704-90B7-D5F46362C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069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07FF3E-051E-41E9-ADE3-8D305B9578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A68078-1DBF-427F-A7BB-1D46B4E82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055424-2BD7-444F-B0A6-14AFF7982C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89AB9-1E15-40EB-B79D-F9782953A82E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A0691A-9D56-49F6-B00A-B42F5C4EE2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1E5C4-D6A7-4E79-8965-C24D775B1A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93D02-5060-452E-92DA-EADA3AE66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074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G"/><Relationship Id="rId13" Type="http://schemas.openxmlformats.org/officeDocument/2006/relationships/image" Target="../media/image8.JP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image" Target="../media/image7.JP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JPG"/><Relationship Id="rId5" Type="http://schemas.openxmlformats.org/officeDocument/2006/relationships/image" Target="../media/image1.emf"/><Relationship Id="rId10" Type="http://schemas.openxmlformats.org/officeDocument/2006/relationships/image" Target="../media/image5.JPG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JP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5.png"/><Relationship Id="rId18" Type="http://schemas.microsoft.com/office/2007/relationships/hdphoto" Target="../media/hdphoto6.wdp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png"/><Relationship Id="rId12" Type="http://schemas.microsoft.com/office/2007/relationships/hdphoto" Target="../media/hdphoto3.wdp"/><Relationship Id="rId17" Type="http://schemas.openxmlformats.org/officeDocument/2006/relationships/image" Target="../media/image17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5.wdp"/><Relationship Id="rId20" Type="http://schemas.openxmlformats.org/officeDocument/2006/relationships/image" Target="../media/image10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11" Type="http://schemas.openxmlformats.org/officeDocument/2006/relationships/image" Target="../media/image14.png"/><Relationship Id="rId5" Type="http://schemas.openxmlformats.org/officeDocument/2006/relationships/oleObject" Target="../embeddings/oleObject3.bin"/><Relationship Id="rId15" Type="http://schemas.openxmlformats.org/officeDocument/2006/relationships/image" Target="../media/image16.png"/><Relationship Id="rId10" Type="http://schemas.microsoft.com/office/2007/relationships/hdphoto" Target="../media/hdphoto2.wdp"/><Relationship Id="rId19" Type="http://schemas.openxmlformats.org/officeDocument/2006/relationships/oleObject" Target="../embeddings/oleObject4.bin"/><Relationship Id="rId4" Type="http://schemas.openxmlformats.org/officeDocument/2006/relationships/image" Target="../media/image11.PNG"/><Relationship Id="rId9" Type="http://schemas.openxmlformats.org/officeDocument/2006/relationships/image" Target="../media/image13.png"/><Relationship Id="rId14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18.emf"/><Relationship Id="rId10" Type="http://schemas.openxmlformats.org/officeDocument/2006/relationships/image" Target="../media/image21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04C78B02-1235-4FC1-BD36-AF733483B1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2668191"/>
              </p:ext>
            </p:extLst>
          </p:nvPr>
        </p:nvGraphicFramePr>
        <p:xfrm>
          <a:off x="107950" y="3611563"/>
          <a:ext cx="6624638" cy="3292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80" name="Prism 9" r:id="rId4" imgW="5401676" imgH="2685592" progId="Prism9.Document">
                  <p:embed/>
                </p:oleObj>
              </mc:Choice>
              <mc:Fallback>
                <p:oleObj name="Prism 9" r:id="rId4" imgW="5401676" imgH="2685592" progId="Prism9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04C78B02-1235-4FC1-BD36-AF733483B1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7950" y="3611563"/>
                        <a:ext cx="6624638" cy="3292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7E3ECD06-1831-4982-BFB2-FC3C6F90E8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0033105"/>
              </p:ext>
            </p:extLst>
          </p:nvPr>
        </p:nvGraphicFramePr>
        <p:xfrm>
          <a:off x="117475" y="-115888"/>
          <a:ext cx="4324350" cy="42767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81" name="Prism 9" r:id="rId6" imgW="3774943" imgH="3731168" progId="Prism9.Document">
                  <p:embed/>
                </p:oleObj>
              </mc:Choice>
              <mc:Fallback>
                <p:oleObj name="Prism 9" r:id="rId6" imgW="3774943" imgH="3731168" progId="Prism9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7E3ECD06-1831-4982-BFB2-FC3C6F90E8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7475" y="-115888"/>
                        <a:ext cx="4324350" cy="42767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E8071581-DC44-4902-B07D-A6E07ADB0D82}"/>
              </a:ext>
            </a:extLst>
          </p:cNvPr>
          <p:cNvGrpSpPr/>
          <p:nvPr/>
        </p:nvGrpSpPr>
        <p:grpSpPr>
          <a:xfrm>
            <a:off x="8109857" y="882940"/>
            <a:ext cx="3701143" cy="5170182"/>
            <a:chOff x="9516285" y="2878822"/>
            <a:chExt cx="2599515" cy="3721369"/>
          </a:xfrm>
        </p:grpSpPr>
        <p:pic>
          <p:nvPicPr>
            <p:cNvPr id="5" name="Content Placeholder 4">
              <a:extLst>
                <a:ext uri="{FF2B5EF4-FFF2-40B4-BE49-F238E27FC236}">
                  <a16:creationId xmlns:a16="http://schemas.microsoft.com/office/drawing/2014/main" id="{EDBCD962-66D2-43D5-81D7-24DE64FBCF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05" t="32997" r="33941" b="48097"/>
            <a:stretch/>
          </p:blipFill>
          <p:spPr>
            <a:xfrm>
              <a:off x="10435710" y="2878822"/>
              <a:ext cx="1672174" cy="591959"/>
            </a:xfrm>
            <a:prstGeom prst="rect">
              <a:avLst/>
            </a:prstGeom>
          </p:spPr>
        </p:pic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8956152-3435-4511-9083-750454433853}"/>
                </a:ext>
              </a:extLst>
            </p:cNvPr>
            <p:cNvCxnSpPr>
              <a:cxnSpLocks/>
            </p:cNvCxnSpPr>
            <p:nvPr/>
          </p:nvCxnSpPr>
          <p:spPr>
            <a:xfrm>
              <a:off x="10465019" y="2995123"/>
              <a:ext cx="0" cy="18424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981FE90-ABF3-452D-B5A2-D8955571BD03}"/>
                </a:ext>
              </a:extLst>
            </p:cNvPr>
            <p:cNvGrpSpPr/>
            <p:nvPr/>
          </p:nvGrpSpPr>
          <p:grpSpPr>
            <a:xfrm>
              <a:off x="10435710" y="3487906"/>
              <a:ext cx="1672174" cy="625671"/>
              <a:chOff x="149687" y="5466638"/>
              <a:chExt cx="1672174" cy="625671"/>
            </a:xfrm>
          </p:grpSpPr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E7A43591-97B0-4F78-94CE-9B5F749DD3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42" t="20423" r="38529" b="59375"/>
              <a:stretch/>
            </p:blipFill>
            <p:spPr>
              <a:xfrm>
                <a:off x="149687" y="5466638"/>
                <a:ext cx="1672174" cy="625671"/>
              </a:xfrm>
              <a:prstGeom prst="rect">
                <a:avLst/>
              </a:prstGeom>
            </p:spPr>
          </p:pic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6215AE0C-3D94-4D55-B578-4F3BB93AEF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821" y="5686834"/>
                <a:ext cx="0" cy="184248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73DECAA-2646-4432-95B5-95AE21AB832A}"/>
                </a:ext>
              </a:extLst>
            </p:cNvPr>
            <p:cNvGrpSpPr/>
            <p:nvPr/>
          </p:nvGrpSpPr>
          <p:grpSpPr>
            <a:xfrm>
              <a:off x="10435711" y="4126652"/>
              <a:ext cx="1680089" cy="622744"/>
              <a:chOff x="4461798" y="4835080"/>
              <a:chExt cx="1548483" cy="622744"/>
            </a:xfrm>
          </p:grpSpPr>
          <p:pic>
            <p:nvPicPr>
              <p:cNvPr id="21" name="Content Placeholder 5">
                <a:extLst>
                  <a:ext uri="{FF2B5EF4-FFF2-40B4-BE49-F238E27FC236}">
                    <a16:creationId xmlns:a16="http://schemas.microsoft.com/office/drawing/2014/main" id="{BAB8745A-B171-4358-A07B-80033B514E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202" t="39056" r="31762" b="43199"/>
              <a:stretch/>
            </p:blipFill>
            <p:spPr>
              <a:xfrm>
                <a:off x="4461798" y="4835080"/>
                <a:ext cx="1548483" cy="622744"/>
              </a:xfrm>
              <a:prstGeom prst="rect">
                <a:avLst/>
              </a:prstGeom>
            </p:spPr>
          </p:pic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A37AB131-E196-4FED-8260-D581BCD432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96023" y="4997352"/>
                <a:ext cx="0" cy="184248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D453F90-E444-4E9A-9127-60B6CC6FA6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28" t="27534" r="33586" b="55841"/>
            <a:stretch/>
          </p:blipFill>
          <p:spPr>
            <a:xfrm>
              <a:off x="10439667" y="4769448"/>
              <a:ext cx="1672175" cy="592332"/>
            </a:xfrm>
            <a:prstGeom prst="rect">
              <a:avLst/>
            </a:prstGeom>
          </p:spPr>
        </p:pic>
        <p:pic>
          <p:nvPicPr>
            <p:cNvPr id="10" name="Content Placeholder 5">
              <a:extLst>
                <a:ext uri="{FF2B5EF4-FFF2-40B4-BE49-F238E27FC236}">
                  <a16:creationId xmlns:a16="http://schemas.microsoft.com/office/drawing/2014/main" id="{C7402C59-035F-4DD0-8450-5D03354BFD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62" t="19391" r="26272" b="64713"/>
            <a:stretch/>
          </p:blipFill>
          <p:spPr>
            <a:xfrm>
              <a:off x="10435709" y="5384840"/>
              <a:ext cx="1680089" cy="592332"/>
            </a:xfrm>
            <a:prstGeom prst="rect">
              <a:avLst/>
            </a:prstGeom>
          </p:spPr>
        </p:pic>
        <p:sp>
          <p:nvSpPr>
            <p:cNvPr id="11" name="TextBox 6">
              <a:extLst>
                <a:ext uri="{FF2B5EF4-FFF2-40B4-BE49-F238E27FC236}">
                  <a16:creationId xmlns:a16="http://schemas.microsoft.com/office/drawing/2014/main" id="{201AF095-E19A-4799-8AA1-5CC377D0BA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55354" y="6267896"/>
              <a:ext cx="923168" cy="3322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i="1" dirty="0">
                  <a:solidFill>
                    <a:srgbClr val="000000"/>
                  </a:solidFill>
                </a:rPr>
                <a:t>MIP-3</a:t>
              </a:r>
              <a:r>
                <a:rPr lang="el-GR" altLang="en-US" sz="1200" i="1" dirty="0">
                  <a:solidFill>
                    <a:srgbClr val="000000"/>
                  </a:solidFill>
                </a:rPr>
                <a:t>α/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rel</a:t>
              </a:r>
              <a:r>
                <a:rPr lang="en-US" altLang="en-US" sz="1200" i="1" baseline="-25000" dirty="0">
                  <a:solidFill>
                    <a:srgbClr val="000000"/>
                  </a:solidFill>
                </a:rPr>
                <a:t>Mtb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200" dirty="0">
                  <a:solidFill>
                    <a:srgbClr val="000000"/>
                  </a:solidFill>
                </a:rPr>
                <a:t>IN  &amp; INH </a:t>
              </a:r>
              <a:endParaRPr lang="en-US" altLang="en-US" sz="1200" dirty="0"/>
            </a:p>
          </p:txBody>
        </p:sp>
        <p:sp>
          <p:nvSpPr>
            <p:cNvPr id="12" name="TextBox 6">
              <a:extLst>
                <a:ext uri="{FF2B5EF4-FFF2-40B4-BE49-F238E27FC236}">
                  <a16:creationId xmlns:a16="http://schemas.microsoft.com/office/drawing/2014/main" id="{4392D18F-F142-4062-92F2-218BA5974F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40389" y="5543089"/>
              <a:ext cx="923168" cy="3322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i="1" dirty="0">
                  <a:solidFill>
                    <a:srgbClr val="000000"/>
                  </a:solidFill>
                </a:rPr>
                <a:t>MIP-3</a:t>
              </a:r>
              <a:r>
                <a:rPr lang="el-GR" altLang="en-US" sz="1200" i="1" dirty="0">
                  <a:solidFill>
                    <a:srgbClr val="000000"/>
                  </a:solidFill>
                </a:rPr>
                <a:t>α/</a:t>
              </a:r>
              <a:r>
                <a:rPr lang="en-US" altLang="en-US" sz="1200" i="1" dirty="0" err="1">
                  <a:solidFill>
                    <a:srgbClr val="000000"/>
                  </a:solidFill>
                </a:rPr>
                <a:t>rel</a:t>
              </a:r>
              <a:r>
                <a:rPr lang="en-US" altLang="en-US" sz="1200" i="1" baseline="-25000" dirty="0" err="1">
                  <a:solidFill>
                    <a:srgbClr val="000000"/>
                  </a:solidFill>
                </a:rPr>
                <a:t>Mtb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200" dirty="0">
                  <a:solidFill>
                    <a:srgbClr val="000000"/>
                  </a:solidFill>
                </a:rPr>
                <a:t>IM &amp; INH </a:t>
              </a:r>
              <a:endParaRPr lang="en-US" altLang="en-US" sz="1200" dirty="0"/>
            </a:p>
          </p:txBody>
        </p:sp>
        <p:sp>
          <p:nvSpPr>
            <p:cNvPr id="13" name="TextBox 6">
              <a:extLst>
                <a:ext uri="{FF2B5EF4-FFF2-40B4-BE49-F238E27FC236}">
                  <a16:creationId xmlns:a16="http://schemas.microsoft.com/office/drawing/2014/main" id="{7165AFF4-0339-4801-977A-248C236E72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61268" y="4937752"/>
              <a:ext cx="923168" cy="199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i="1" dirty="0" err="1">
                  <a:solidFill>
                    <a:srgbClr val="000000"/>
                  </a:solidFill>
                </a:rPr>
                <a:t>rel</a:t>
              </a:r>
              <a:r>
                <a:rPr lang="en-US" altLang="en-US" sz="1200" i="1" baseline="-25000" dirty="0" err="1">
                  <a:solidFill>
                    <a:srgbClr val="000000"/>
                  </a:solidFill>
                </a:rPr>
                <a:t>Mtb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200" dirty="0">
                  <a:solidFill>
                    <a:srgbClr val="000000"/>
                  </a:solidFill>
                </a:rPr>
                <a:t>IN &amp; INH </a:t>
              </a:r>
              <a:endParaRPr lang="en-US" altLang="en-US" sz="1200" dirty="0"/>
            </a:p>
          </p:txBody>
        </p:sp>
        <p:sp>
          <p:nvSpPr>
            <p:cNvPr id="14" name="TextBox 6">
              <a:extLst>
                <a:ext uri="{FF2B5EF4-FFF2-40B4-BE49-F238E27FC236}">
                  <a16:creationId xmlns:a16="http://schemas.microsoft.com/office/drawing/2014/main" id="{DAB18CB3-1A9B-4B27-ADDE-040F201B27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31110" y="4296753"/>
              <a:ext cx="923168" cy="199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i="1" dirty="0" err="1">
                  <a:solidFill>
                    <a:srgbClr val="000000"/>
                  </a:solidFill>
                </a:rPr>
                <a:t>rel</a:t>
              </a:r>
              <a:r>
                <a:rPr lang="en-US" altLang="en-US" sz="1200" i="1" baseline="-25000" dirty="0" err="1">
                  <a:solidFill>
                    <a:srgbClr val="000000"/>
                  </a:solidFill>
                </a:rPr>
                <a:t>Mtb</a:t>
              </a:r>
              <a:r>
                <a:rPr lang="en-US" altLang="en-US" sz="12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1200" dirty="0">
                  <a:solidFill>
                    <a:srgbClr val="000000"/>
                  </a:solidFill>
                </a:rPr>
                <a:t>IM &amp; INH </a:t>
              </a:r>
              <a:endParaRPr lang="en-US" altLang="en-US" sz="1200" dirty="0"/>
            </a:p>
          </p:txBody>
        </p:sp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A2703C16-B0B0-4B5F-9D3D-FD8D8AEAF9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16285" y="3698689"/>
              <a:ext cx="923168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dirty="0">
                  <a:solidFill>
                    <a:srgbClr val="000000"/>
                  </a:solidFill>
                </a:rPr>
                <a:t> INH </a:t>
              </a:r>
              <a:endParaRPr lang="en-US" altLang="en-US" sz="1200" dirty="0"/>
            </a:p>
          </p:txBody>
        </p:sp>
        <p:sp>
          <p:nvSpPr>
            <p:cNvPr id="16" name="TextBox 6">
              <a:extLst>
                <a:ext uri="{FF2B5EF4-FFF2-40B4-BE49-F238E27FC236}">
                  <a16:creationId xmlns:a16="http://schemas.microsoft.com/office/drawing/2014/main" id="{32B13CC9-D49A-4F65-9ACE-3EED26CA75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61268" y="3067282"/>
              <a:ext cx="923168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200" dirty="0">
                  <a:solidFill>
                    <a:srgbClr val="000000"/>
                  </a:solidFill>
                </a:rPr>
                <a:t>Control </a:t>
              </a:r>
              <a:endParaRPr lang="en-US" altLang="en-US" sz="1200" dirty="0"/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D503A0B2-D57D-4C7C-9518-2B2AA1D5157B}"/>
                </a:ext>
              </a:extLst>
            </p:cNvPr>
            <p:cNvCxnSpPr>
              <a:cxnSpLocks/>
            </p:cNvCxnSpPr>
            <p:nvPr/>
          </p:nvCxnSpPr>
          <p:spPr>
            <a:xfrm>
              <a:off x="10467684" y="4933715"/>
              <a:ext cx="0" cy="18424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EB76EB22-B7B4-42B7-B6DE-87D4CEFB02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91" t="15454" r="37074" b="66923"/>
            <a:stretch/>
          </p:blipFill>
          <p:spPr>
            <a:xfrm>
              <a:off x="10430416" y="5991710"/>
              <a:ext cx="1676332" cy="592332"/>
            </a:xfrm>
            <a:prstGeom prst="rect">
              <a:avLst/>
            </a:prstGeom>
          </p:spPr>
        </p:pic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9ECA739C-D9A9-4CB9-86D4-CCBA46890A3D}"/>
                </a:ext>
              </a:extLst>
            </p:cNvPr>
            <p:cNvCxnSpPr>
              <a:cxnSpLocks/>
            </p:cNvCxnSpPr>
            <p:nvPr/>
          </p:nvCxnSpPr>
          <p:spPr>
            <a:xfrm>
              <a:off x="10456930" y="6267896"/>
              <a:ext cx="0" cy="18424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AC7CEEDB-51F9-421B-8400-5E74CAAE34C1}"/>
                </a:ext>
              </a:extLst>
            </p:cNvPr>
            <p:cNvCxnSpPr>
              <a:cxnSpLocks/>
            </p:cNvCxnSpPr>
            <p:nvPr/>
          </p:nvCxnSpPr>
          <p:spPr>
            <a:xfrm>
              <a:off x="10463557" y="5607078"/>
              <a:ext cx="0" cy="18424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FC93038-8E70-44F6-9F4B-7547201DDAD2}"/>
              </a:ext>
            </a:extLst>
          </p:cNvPr>
          <p:cNvSpPr txBox="1"/>
          <p:nvPr/>
        </p:nvSpPr>
        <p:spPr>
          <a:xfrm>
            <a:off x="185057" y="0"/>
            <a:ext cx="39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5B72EC3-E61B-4B28-9FAF-5D02E43FBD3B}"/>
              </a:ext>
            </a:extLst>
          </p:cNvPr>
          <p:cNvSpPr txBox="1"/>
          <p:nvPr/>
        </p:nvSpPr>
        <p:spPr>
          <a:xfrm>
            <a:off x="185057" y="3422163"/>
            <a:ext cx="39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4C44B56-3DF3-4858-BC14-D947C15951F6}"/>
              </a:ext>
            </a:extLst>
          </p:cNvPr>
          <p:cNvSpPr txBox="1"/>
          <p:nvPr/>
        </p:nvSpPr>
        <p:spPr>
          <a:xfrm>
            <a:off x="7913914" y="450809"/>
            <a:ext cx="39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A5685F-740B-450D-A3E9-123EE29F178B}"/>
              </a:ext>
            </a:extLst>
          </p:cNvPr>
          <p:cNvSpPr txBox="1"/>
          <p:nvPr/>
        </p:nvSpPr>
        <p:spPr>
          <a:xfrm>
            <a:off x="10461812" y="6427694"/>
            <a:ext cx="16270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193090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98507A97-012B-46AC-B21F-43949F9624C1}"/>
              </a:ext>
            </a:extLst>
          </p:cNvPr>
          <p:cNvGrpSpPr/>
          <p:nvPr/>
        </p:nvGrpSpPr>
        <p:grpSpPr>
          <a:xfrm>
            <a:off x="748686" y="847879"/>
            <a:ext cx="5559189" cy="2046464"/>
            <a:chOff x="2235683" y="148813"/>
            <a:chExt cx="7838781" cy="2723695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5117B001-DA20-48F6-B7B5-8D002DEE09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5683" y="148813"/>
              <a:ext cx="7838781" cy="272369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93C9F4E-4BBC-4226-8C20-0C613385E1D9}"/>
                </a:ext>
              </a:extLst>
            </p:cNvPr>
            <p:cNvSpPr txBox="1"/>
            <p:nvPr/>
          </p:nvSpPr>
          <p:spPr>
            <a:xfrm>
              <a:off x="9024359" y="2179178"/>
              <a:ext cx="999858" cy="52129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63751B6-7499-4180-8515-9F3193524BAA}"/>
                </a:ext>
              </a:extLst>
            </p:cNvPr>
            <p:cNvSpPr txBox="1"/>
            <p:nvPr/>
          </p:nvSpPr>
          <p:spPr>
            <a:xfrm>
              <a:off x="9024359" y="1568302"/>
              <a:ext cx="348241" cy="52129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A7B8710-2A0A-445C-B2CB-D395514386C7}"/>
                </a:ext>
              </a:extLst>
            </p:cNvPr>
            <p:cNvSpPr txBox="1"/>
            <p:nvPr/>
          </p:nvSpPr>
          <p:spPr>
            <a:xfrm>
              <a:off x="9463838" y="1510660"/>
              <a:ext cx="348241" cy="52129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C438CC61-7D05-4D2D-A1BB-9E3396D1F2E7}"/>
              </a:ext>
            </a:extLst>
          </p:cNvPr>
          <p:cNvGrpSpPr/>
          <p:nvPr/>
        </p:nvGrpSpPr>
        <p:grpSpPr>
          <a:xfrm>
            <a:off x="3427183" y="3573366"/>
            <a:ext cx="4732477" cy="2876550"/>
            <a:chOff x="7842111" y="3398838"/>
            <a:chExt cx="4732477" cy="2876550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029D6978-9565-46E3-AC97-D696C1FE843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3391610"/>
                </p:ext>
              </p:extLst>
            </p:nvPr>
          </p:nvGraphicFramePr>
          <p:xfrm>
            <a:off x="8105775" y="3398838"/>
            <a:ext cx="4468813" cy="2876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386" name="Prism 9" r:id="rId5" imgW="3771701" imgH="2428158" progId="Prism9.Document">
                    <p:embed/>
                  </p:oleObj>
                </mc:Choice>
                <mc:Fallback>
                  <p:oleObj name="Prism 9" r:id="rId5" imgW="3771701" imgH="2428158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029D6978-9565-46E3-AC97-D696C1FE843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105775" y="3398838"/>
                          <a:ext cx="4468813" cy="2876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13CAA99-2E35-47D8-98CD-CF3C5AA787D3}"/>
                </a:ext>
              </a:extLst>
            </p:cNvPr>
            <p:cNvSpPr txBox="1"/>
            <p:nvPr/>
          </p:nvSpPr>
          <p:spPr>
            <a:xfrm>
              <a:off x="8133795" y="3514275"/>
              <a:ext cx="2617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F7B6CE58-44AB-4BB5-BE47-6FFD38D551CF}"/>
                </a:ext>
              </a:extLst>
            </p:cNvPr>
            <p:cNvGrpSpPr/>
            <p:nvPr/>
          </p:nvGrpSpPr>
          <p:grpSpPr>
            <a:xfrm>
              <a:off x="7842111" y="4134605"/>
              <a:ext cx="465931" cy="1361660"/>
              <a:chOff x="360541" y="943933"/>
              <a:chExt cx="465931" cy="1361660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0F457EB-E4A4-43DA-9B80-A0F77B5F1BE0}"/>
                  </a:ext>
                </a:extLst>
              </p:cNvPr>
              <p:cNvSpPr txBox="1"/>
              <p:nvPr/>
            </p:nvSpPr>
            <p:spPr>
              <a:xfrm rot="16200000">
                <a:off x="7143" y="1486263"/>
                <a:ext cx="13616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CD3+CD4+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4430F34-A494-4092-AFFE-1602E6E3177E}"/>
                  </a:ext>
                </a:extLst>
              </p:cNvPr>
              <p:cNvSpPr txBox="1"/>
              <p:nvPr/>
            </p:nvSpPr>
            <p:spPr>
              <a:xfrm rot="16200000">
                <a:off x="-31845" y="1507941"/>
                <a:ext cx="10617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PBMC</a:t>
                </a:r>
              </a:p>
            </p:txBody>
          </p: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A31641C2-EFF1-4370-B0FD-D0BFC9D607F0}"/>
              </a:ext>
            </a:extLst>
          </p:cNvPr>
          <p:cNvSpPr txBox="1"/>
          <p:nvPr/>
        </p:nvSpPr>
        <p:spPr>
          <a:xfrm>
            <a:off x="113603" y="478546"/>
            <a:ext cx="194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3FECFA6-4B32-4309-9D53-2391F76E63D1}"/>
              </a:ext>
            </a:extLst>
          </p:cNvPr>
          <p:cNvGrpSpPr/>
          <p:nvPr/>
        </p:nvGrpSpPr>
        <p:grpSpPr>
          <a:xfrm>
            <a:off x="9083014" y="1003136"/>
            <a:ext cx="2948441" cy="1140944"/>
            <a:chOff x="4578321" y="3647179"/>
            <a:chExt cx="6773461" cy="2580693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5AF4C757-9A95-45C0-A842-3CBC1097869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16935" y="3661694"/>
              <a:ext cx="1234847" cy="1234847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B4ED19D0-CB0C-4F8D-A43A-10508CF387F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7656" y="3647179"/>
              <a:ext cx="1234848" cy="1234848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1A102350-AE67-405A-9DBE-03701E6160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16376" y="3661694"/>
              <a:ext cx="1234847" cy="1234847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BD27E08-4C4C-4CBE-A97D-C8FE50E4C8A2}"/>
                </a:ext>
              </a:extLst>
            </p:cNvPr>
            <p:cNvSpPr txBox="1"/>
            <p:nvPr/>
          </p:nvSpPr>
          <p:spPr>
            <a:xfrm>
              <a:off x="4578321" y="4049685"/>
              <a:ext cx="2927903" cy="62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MIP</a:t>
              </a:r>
              <a:r>
                <a:rPr lang="el-GR" sz="1200" dirty="0"/>
                <a:t>-</a:t>
              </a:r>
              <a:r>
                <a:rPr lang="en-US" sz="1200" dirty="0"/>
                <a:t>3</a:t>
              </a:r>
              <a:r>
                <a:rPr lang="el-GR" sz="1200" dirty="0"/>
                <a:t>α</a:t>
              </a:r>
              <a:r>
                <a:rPr lang="en-US" sz="1200" dirty="0"/>
                <a:t>/</a:t>
              </a:r>
              <a:r>
                <a:rPr lang="en-US" sz="1200" dirty="0" err="1"/>
                <a:t>rel</a:t>
              </a:r>
              <a:r>
                <a:rPr lang="en-US" sz="1200" baseline="-25000" dirty="0" err="1"/>
                <a:t>Mtb</a:t>
              </a:r>
              <a:r>
                <a:rPr lang="en-US" sz="1200" dirty="0"/>
                <a:t> IM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3304490B-C422-4650-9726-0BA9F53380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7364" y="4993024"/>
              <a:ext cx="1234847" cy="1234847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A4DFC52E-015E-4FD8-82D2-72A610E110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7656" y="4993023"/>
              <a:ext cx="1234848" cy="1234848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4C095286-D8F9-4E6D-B44E-8FFDA63CA32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duotone>
                <a:prstClr val="black"/>
                <a:srgbClr val="00B050">
                  <a:tint val="45000"/>
                  <a:satMod val="400000"/>
                </a:srgbClr>
              </a:duotone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16935" y="4993025"/>
              <a:ext cx="1234847" cy="1234847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2D32F89-0AD6-40CE-B40B-3F8E3A547AE7}"/>
                </a:ext>
              </a:extLst>
            </p:cNvPr>
            <p:cNvSpPr txBox="1"/>
            <p:nvPr/>
          </p:nvSpPr>
          <p:spPr>
            <a:xfrm>
              <a:off x="5331132" y="5306055"/>
              <a:ext cx="1962745" cy="6498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rel</a:t>
              </a:r>
              <a:r>
                <a:rPr lang="en-US" sz="1200" baseline="-25000" dirty="0"/>
                <a:t>Mtb </a:t>
              </a:r>
              <a:r>
                <a:rPr lang="en-US" sz="1200" dirty="0"/>
                <a:t>IM </a:t>
              </a:r>
            </a:p>
          </p:txBody>
        </p:sp>
      </p:grpSp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E1CC7708-250E-469D-A7D0-FA188A1283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9006398"/>
              </p:ext>
            </p:extLst>
          </p:nvPr>
        </p:nvGraphicFramePr>
        <p:xfrm>
          <a:off x="6853922" y="557796"/>
          <a:ext cx="2003425" cy="2749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387" name="Prism 9" r:id="rId19" imgW="2212314" imgH="3037718" progId="Prism9.Document">
                  <p:embed/>
                </p:oleObj>
              </mc:Choice>
              <mc:Fallback>
                <p:oleObj name="Prism 9" r:id="rId19" imgW="2212314" imgH="3037718" progId="Prism9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E1CC7708-250E-469D-A7D0-FA188A1283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853922" y="557796"/>
                        <a:ext cx="2003425" cy="2749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TextBox 47">
            <a:extLst>
              <a:ext uri="{FF2B5EF4-FFF2-40B4-BE49-F238E27FC236}">
                <a16:creationId xmlns:a16="http://schemas.microsoft.com/office/drawing/2014/main" id="{F138143C-CEC3-4A4A-AFEA-8C5A76B50CFF}"/>
              </a:ext>
            </a:extLst>
          </p:cNvPr>
          <p:cNvSpPr txBox="1"/>
          <p:nvPr/>
        </p:nvSpPr>
        <p:spPr>
          <a:xfrm>
            <a:off x="6574754" y="523942"/>
            <a:ext cx="438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FC19FAA-28E2-4BD3-A3C5-DA6F70EE552C}"/>
              </a:ext>
            </a:extLst>
          </p:cNvPr>
          <p:cNvSpPr txBox="1"/>
          <p:nvPr/>
        </p:nvSpPr>
        <p:spPr>
          <a:xfrm>
            <a:off x="8804039" y="478547"/>
            <a:ext cx="5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49845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CA858C5B-B868-4AFE-A4BF-585CE5317020}"/>
              </a:ext>
            </a:extLst>
          </p:cNvPr>
          <p:cNvGrpSpPr/>
          <p:nvPr/>
        </p:nvGrpSpPr>
        <p:grpSpPr>
          <a:xfrm>
            <a:off x="7428205" y="3203580"/>
            <a:ext cx="3778450" cy="3351052"/>
            <a:chOff x="5235895" y="1789589"/>
            <a:chExt cx="2625537" cy="2167882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3DA4CB74-5DBB-4728-848E-04B5C957E8E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298026"/>
                </p:ext>
              </p:extLst>
            </p:nvPr>
          </p:nvGraphicFramePr>
          <p:xfrm>
            <a:off x="5479684" y="1789589"/>
            <a:ext cx="2381748" cy="21678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8429" name="Prism 9" r:id="rId4" imgW="3492956" imgH="3179576" progId="Prism9.Document">
                    <p:embed/>
                  </p:oleObj>
                </mc:Choice>
                <mc:Fallback>
                  <p:oleObj name="Prism 9" r:id="rId4" imgW="3492956" imgH="3179576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A1201271-176C-4B34-B7C1-39CACDFD75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479684" y="1789589"/>
                          <a:ext cx="2381748" cy="21678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538FECF-9909-4356-88C0-DB9E3F422BEA}"/>
                </a:ext>
              </a:extLst>
            </p:cNvPr>
            <p:cNvSpPr txBox="1"/>
            <p:nvPr/>
          </p:nvSpPr>
          <p:spPr>
            <a:xfrm rot="16200000">
              <a:off x="4813173" y="2609132"/>
              <a:ext cx="1361660" cy="211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D3+CD4+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B0E97B9-534D-4697-8F65-1DAFE2D4CDCE}"/>
                </a:ext>
              </a:extLst>
            </p:cNvPr>
            <p:cNvSpPr txBox="1"/>
            <p:nvPr/>
          </p:nvSpPr>
          <p:spPr>
            <a:xfrm rot="16200000">
              <a:off x="4810810" y="2641686"/>
              <a:ext cx="1061772" cy="2116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Lymph Node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922DA61-B9B0-461F-BF0F-08A81C2299F8}"/>
              </a:ext>
            </a:extLst>
          </p:cNvPr>
          <p:cNvSpPr txBox="1"/>
          <p:nvPr/>
        </p:nvSpPr>
        <p:spPr>
          <a:xfrm>
            <a:off x="1636341" y="3424612"/>
            <a:ext cx="286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45A65A90-7E78-46DF-B609-26EACEEB1209}"/>
              </a:ext>
            </a:extLst>
          </p:cNvPr>
          <p:cNvGrpSpPr/>
          <p:nvPr/>
        </p:nvGrpSpPr>
        <p:grpSpPr>
          <a:xfrm>
            <a:off x="1670544" y="3384394"/>
            <a:ext cx="6108501" cy="3170238"/>
            <a:chOff x="3993090" y="1560383"/>
            <a:chExt cx="6108501" cy="3170238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1CF968BD-A607-4DFC-B9B6-F4CD79175D9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9062035"/>
                </p:ext>
              </p:extLst>
            </p:nvPr>
          </p:nvGraphicFramePr>
          <p:xfrm>
            <a:off x="4268424" y="1560383"/>
            <a:ext cx="3484563" cy="31702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8430" name="Prism 9" r:id="rId6" imgW="3486834" imgH="3173455" progId="Prism9.Document">
                    <p:embed/>
                  </p:oleObj>
                </mc:Choice>
                <mc:Fallback>
                  <p:oleObj name="Prism 9" r:id="rId6" imgW="3486834" imgH="3173455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BA2A1707-CF0E-4241-97B6-4C1A3676815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268424" y="1560383"/>
                          <a:ext cx="3484563" cy="31702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6DF4A24A-D257-48EE-AC4D-0E2F32B3CAEA}"/>
                </a:ext>
              </a:extLst>
            </p:cNvPr>
            <p:cNvGrpSpPr/>
            <p:nvPr/>
          </p:nvGrpSpPr>
          <p:grpSpPr>
            <a:xfrm>
              <a:off x="3993090" y="2218003"/>
              <a:ext cx="453394" cy="1361660"/>
              <a:chOff x="398754" y="906862"/>
              <a:chExt cx="453394" cy="1361660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AB63036-DBAA-4919-9AC2-808FD32D7057}"/>
                  </a:ext>
                </a:extLst>
              </p:cNvPr>
              <p:cNvSpPr txBox="1"/>
              <p:nvPr/>
            </p:nvSpPr>
            <p:spPr>
              <a:xfrm rot="16200000">
                <a:off x="32819" y="1449192"/>
                <a:ext cx="13616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CD3+CD4+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2C78E56-4679-45B0-A680-940EC6857B1A}"/>
                  </a:ext>
                </a:extLst>
              </p:cNvPr>
              <p:cNvSpPr txBox="1"/>
              <p:nvPr/>
            </p:nvSpPr>
            <p:spPr>
              <a:xfrm rot="16200000">
                <a:off x="6368" y="1486262"/>
                <a:ext cx="10617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PBMC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F00E531-F862-4D8C-84A1-51F98444F638}"/>
                </a:ext>
              </a:extLst>
            </p:cNvPr>
            <p:cNvSpPr txBox="1"/>
            <p:nvPr/>
          </p:nvSpPr>
          <p:spPr>
            <a:xfrm>
              <a:off x="9799637" y="1627182"/>
              <a:ext cx="3019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</p:grp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89FF3B44-6EB9-4E38-8E14-B219536F11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5240615"/>
              </p:ext>
            </p:extLst>
          </p:nvPr>
        </p:nvGraphicFramePr>
        <p:xfrm>
          <a:off x="2094630" y="529084"/>
          <a:ext cx="3099114" cy="25523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31" name="Prism 9" r:id="rId8" imgW="3742890" imgH="3082004" progId="Prism9.Document">
                  <p:embed/>
                </p:oleObj>
              </mc:Choice>
              <mc:Fallback>
                <p:oleObj name="Prism 9" r:id="rId8" imgW="3742890" imgH="3082004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1B2E4F91-4811-47A2-B203-61D6DCB7FB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94630" y="529084"/>
                        <a:ext cx="3099114" cy="25523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42B6DE4A-7738-43BE-9774-27A4ABC9AE9F}"/>
              </a:ext>
            </a:extLst>
          </p:cNvPr>
          <p:cNvSpPr txBox="1"/>
          <p:nvPr/>
        </p:nvSpPr>
        <p:spPr>
          <a:xfrm>
            <a:off x="1627733" y="41064"/>
            <a:ext cx="438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2BF205F-63C9-42A8-B589-3B38636D2426}"/>
              </a:ext>
            </a:extLst>
          </p:cNvPr>
          <p:cNvSpPr txBox="1"/>
          <p:nvPr/>
        </p:nvSpPr>
        <p:spPr>
          <a:xfrm>
            <a:off x="7428205" y="41064"/>
            <a:ext cx="50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245C2F97-DD68-4703-9BF8-44807D3C6903}"/>
              </a:ext>
            </a:extLst>
          </p:cNvPr>
          <p:cNvGrpSpPr/>
          <p:nvPr/>
        </p:nvGrpSpPr>
        <p:grpSpPr>
          <a:xfrm>
            <a:off x="7703538" y="492657"/>
            <a:ext cx="3269261" cy="2117682"/>
            <a:chOff x="1611284" y="3770846"/>
            <a:chExt cx="2308179" cy="1271413"/>
          </a:xfrm>
        </p:grpSpPr>
        <p:pic>
          <p:nvPicPr>
            <p:cNvPr id="20" name="Picture 3">
              <a:extLst>
                <a:ext uri="{FF2B5EF4-FFF2-40B4-BE49-F238E27FC236}">
                  <a16:creationId xmlns:a16="http://schemas.microsoft.com/office/drawing/2014/main" id="{E69AF8E6-AC9A-4EF4-B5F1-912519CADE2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82" t="50535" r="1665"/>
            <a:stretch/>
          </p:blipFill>
          <p:spPr bwMode="auto">
            <a:xfrm>
              <a:off x="2396966" y="4198289"/>
              <a:ext cx="1522497" cy="8439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TextBox 6">
              <a:extLst>
                <a:ext uri="{FF2B5EF4-FFF2-40B4-BE49-F238E27FC236}">
                  <a16:creationId xmlns:a16="http://schemas.microsoft.com/office/drawing/2014/main" id="{D3E0B120-C308-43FC-BA03-7184CEAF01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32689" y="3847989"/>
              <a:ext cx="793627" cy="1676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800" i="1" dirty="0">
                  <a:solidFill>
                    <a:srgbClr val="000000"/>
                  </a:solidFill>
                </a:rPr>
                <a:t>MIP-3</a:t>
              </a:r>
              <a:r>
                <a:rPr lang="el-GR" altLang="en-US" sz="800" i="1" dirty="0">
                  <a:solidFill>
                    <a:srgbClr val="000000"/>
                  </a:solidFill>
                </a:rPr>
                <a:t>α/</a:t>
              </a:r>
              <a:r>
                <a:rPr lang="en-US" altLang="en-US" sz="800" i="1" dirty="0">
                  <a:solidFill>
                    <a:srgbClr val="000000"/>
                  </a:solidFill>
                </a:rPr>
                <a:t>rel</a:t>
              </a:r>
              <a:r>
                <a:rPr lang="en-US" altLang="en-US" sz="800" i="1" baseline="-25000" dirty="0">
                  <a:solidFill>
                    <a:srgbClr val="000000"/>
                  </a:solidFill>
                </a:rPr>
                <a:t>Mtb</a:t>
              </a:r>
              <a:r>
                <a:rPr lang="en-US" altLang="en-US" sz="8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800" dirty="0">
                  <a:solidFill>
                    <a:srgbClr val="000000"/>
                  </a:solidFill>
                </a:rPr>
                <a:t>IN  </a:t>
              </a:r>
              <a:endParaRPr lang="en-US" altLang="en-US" sz="800" dirty="0"/>
            </a:p>
          </p:txBody>
        </p:sp>
        <p:sp>
          <p:nvSpPr>
            <p:cNvPr id="22" name="TextBox 13">
              <a:extLst>
                <a:ext uri="{FF2B5EF4-FFF2-40B4-BE49-F238E27FC236}">
                  <a16:creationId xmlns:a16="http://schemas.microsoft.com/office/drawing/2014/main" id="{687684AD-6317-432F-9B51-29341A7A77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94132" y="4713760"/>
              <a:ext cx="592467" cy="1676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800" i="1" dirty="0">
                  <a:solidFill>
                    <a:srgbClr val="000000"/>
                  </a:solidFill>
                </a:rPr>
                <a:t>rel</a:t>
              </a:r>
              <a:r>
                <a:rPr lang="en-US" altLang="en-US" sz="800" i="1" baseline="-25000" dirty="0">
                  <a:solidFill>
                    <a:srgbClr val="000000"/>
                  </a:solidFill>
                </a:rPr>
                <a:t>Mtb</a:t>
              </a:r>
              <a:r>
                <a:rPr lang="en-US" altLang="en-US" sz="800" dirty="0"/>
                <a:t> IM </a:t>
              </a:r>
            </a:p>
          </p:txBody>
        </p:sp>
        <p:sp>
          <p:nvSpPr>
            <p:cNvPr id="23" name="TextBox 15">
              <a:extLst>
                <a:ext uri="{FF2B5EF4-FFF2-40B4-BE49-F238E27FC236}">
                  <a16:creationId xmlns:a16="http://schemas.microsoft.com/office/drawing/2014/main" id="{B25C9744-D3F4-4086-9727-880DF9E7C7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1284" y="4301600"/>
              <a:ext cx="799281" cy="1676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800" i="1" dirty="0">
                  <a:solidFill>
                    <a:srgbClr val="000000"/>
                  </a:solidFill>
                </a:rPr>
                <a:t>MIP-3</a:t>
              </a:r>
              <a:r>
                <a:rPr lang="el-GR" altLang="en-US" sz="800" i="1" dirty="0">
                  <a:solidFill>
                    <a:srgbClr val="000000"/>
                  </a:solidFill>
                </a:rPr>
                <a:t>α/</a:t>
              </a:r>
              <a:r>
                <a:rPr lang="en-US" altLang="en-US" sz="800" i="1" dirty="0">
                  <a:solidFill>
                    <a:srgbClr val="000000"/>
                  </a:solidFill>
                </a:rPr>
                <a:t>rel</a:t>
              </a:r>
              <a:r>
                <a:rPr lang="en-US" altLang="en-US" sz="800" i="1" baseline="-25000" dirty="0">
                  <a:solidFill>
                    <a:srgbClr val="000000"/>
                  </a:solidFill>
                </a:rPr>
                <a:t>Mtb</a:t>
              </a:r>
              <a:r>
                <a:rPr lang="en-US" altLang="en-US" sz="8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800" dirty="0">
                  <a:solidFill>
                    <a:srgbClr val="000000"/>
                  </a:solidFill>
                </a:rPr>
                <a:t>IM  </a:t>
              </a:r>
              <a:endParaRPr lang="en-US" altLang="en-US" sz="800" dirty="0"/>
            </a:p>
          </p:txBody>
        </p:sp>
        <p:pic>
          <p:nvPicPr>
            <p:cNvPr id="27" name="Picture 3">
              <a:extLst>
                <a:ext uri="{FF2B5EF4-FFF2-40B4-BE49-F238E27FC236}">
                  <a16:creationId xmlns:a16="http://schemas.microsoft.com/office/drawing/2014/main" id="{F5DCCDDA-485B-47D2-99B9-67DF77E27E4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83" r="2184" b="77872"/>
            <a:stretch/>
          </p:blipFill>
          <p:spPr bwMode="auto">
            <a:xfrm>
              <a:off x="2386087" y="3770846"/>
              <a:ext cx="1511576" cy="377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002083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825</TotalTime>
  <Words>79</Words>
  <Application>Microsoft Office PowerPoint</Application>
  <PresentationFormat>Widescreen</PresentationFormat>
  <Paragraphs>32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yliani Karanika</dc:creator>
  <cp:lastModifiedBy>Styliani Karanika</cp:lastModifiedBy>
  <cp:revision>830</cp:revision>
  <dcterms:created xsi:type="dcterms:W3CDTF">2021-11-07T13:46:41Z</dcterms:created>
  <dcterms:modified xsi:type="dcterms:W3CDTF">2022-06-17T02:28:47Z</dcterms:modified>
</cp:coreProperties>
</file>